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310" r:id="rId2"/>
    <p:sldId id="362" r:id="rId3"/>
    <p:sldId id="359" r:id="rId4"/>
  </p:sldIdLst>
  <p:sldSz cx="7019925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2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BC89EF96-8CEA-46FF-86C4-4CE0E7609802}" styleName="淡色スタイル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056"/>
    <p:restoredTop sz="90137"/>
  </p:normalViewPr>
  <p:slideViewPr>
    <p:cSldViewPr snapToGrid="0" showGuides="1">
      <p:cViewPr>
        <p:scale>
          <a:sx n="213" d="100"/>
          <a:sy n="213" d="100"/>
        </p:scale>
        <p:origin x="1072" y="144"/>
      </p:cViewPr>
      <p:guideLst>
        <p:guide orient="horz" pos="3121"/>
        <p:guide pos="221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946F0A-C6A2-EF4C-81F3-9C5841BC77EB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35213" y="1143000"/>
            <a:ext cx="2187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F89BD1-4F87-B647-B844-1233DC4025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000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F89BD1-4F87-B647-B844-1233DC40258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314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6495" y="1621451"/>
            <a:ext cx="5966936" cy="3449308"/>
          </a:xfrm>
        </p:spPr>
        <p:txBody>
          <a:bodyPr anchor="b"/>
          <a:lstStyle>
            <a:lvl1pPr algn="ctr">
              <a:defRPr sz="460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77491" y="5203778"/>
            <a:ext cx="5264944" cy="2392040"/>
          </a:xfrm>
        </p:spPr>
        <p:txBody>
          <a:bodyPr/>
          <a:lstStyle>
            <a:lvl1pPr marL="0" indent="0" algn="ctr">
              <a:buNone/>
              <a:defRPr sz="1842"/>
            </a:lvl1pPr>
            <a:lvl2pPr marL="350992" indent="0" algn="ctr">
              <a:buNone/>
              <a:defRPr sz="1535"/>
            </a:lvl2pPr>
            <a:lvl3pPr marL="701985" indent="0" algn="ctr">
              <a:buNone/>
              <a:defRPr sz="1382"/>
            </a:lvl3pPr>
            <a:lvl4pPr marL="1052977" indent="0" algn="ctr">
              <a:buNone/>
              <a:defRPr sz="1228"/>
            </a:lvl4pPr>
            <a:lvl5pPr marL="1403970" indent="0" algn="ctr">
              <a:buNone/>
              <a:defRPr sz="1228"/>
            </a:lvl5pPr>
            <a:lvl6pPr marL="1754962" indent="0" algn="ctr">
              <a:buNone/>
              <a:defRPr sz="1228"/>
            </a:lvl6pPr>
            <a:lvl7pPr marL="2105955" indent="0" algn="ctr">
              <a:buNone/>
              <a:defRPr sz="1228"/>
            </a:lvl7pPr>
            <a:lvl8pPr marL="2456947" indent="0" algn="ctr">
              <a:buNone/>
              <a:defRPr sz="1228"/>
            </a:lvl8pPr>
            <a:lvl9pPr marL="2807940" indent="0" algn="ctr">
              <a:buNone/>
              <a:defRPr sz="122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4078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358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23634" y="527487"/>
            <a:ext cx="1513671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2620" y="527487"/>
            <a:ext cx="4453265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0273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298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8964" y="2470019"/>
            <a:ext cx="6054685" cy="4121281"/>
          </a:xfrm>
        </p:spPr>
        <p:txBody>
          <a:bodyPr anchor="b"/>
          <a:lstStyle>
            <a:lvl1pPr>
              <a:defRPr sz="460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8964" y="6630289"/>
            <a:ext cx="6054685" cy="2167284"/>
          </a:xfrm>
        </p:spPr>
        <p:txBody>
          <a:bodyPr/>
          <a:lstStyle>
            <a:lvl1pPr marL="0" indent="0">
              <a:buNone/>
              <a:defRPr sz="1842">
                <a:solidFill>
                  <a:schemeClr val="tx1">
                    <a:tint val="82000"/>
                  </a:schemeClr>
                </a:solidFill>
              </a:defRPr>
            </a:lvl1pPr>
            <a:lvl2pPr marL="350992" indent="0">
              <a:buNone/>
              <a:defRPr sz="1535">
                <a:solidFill>
                  <a:schemeClr val="tx1">
                    <a:tint val="82000"/>
                  </a:schemeClr>
                </a:solidFill>
              </a:defRPr>
            </a:lvl2pPr>
            <a:lvl3pPr marL="701985" indent="0">
              <a:buNone/>
              <a:defRPr sz="1382">
                <a:solidFill>
                  <a:schemeClr val="tx1">
                    <a:tint val="82000"/>
                  </a:schemeClr>
                </a:solidFill>
              </a:defRPr>
            </a:lvl3pPr>
            <a:lvl4pPr marL="1052977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4pPr>
            <a:lvl5pPr marL="1403970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5pPr>
            <a:lvl6pPr marL="1754962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6pPr>
            <a:lvl7pPr marL="2105955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7pPr>
            <a:lvl8pPr marL="2456947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8pPr>
            <a:lvl9pPr marL="2807940" indent="0">
              <a:buNone/>
              <a:defRPr sz="122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435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2620" y="2637436"/>
            <a:ext cx="2983468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53837" y="2637436"/>
            <a:ext cx="2983468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7596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527490"/>
            <a:ext cx="605468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35" y="2428736"/>
            <a:ext cx="2969757" cy="1190286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3535" y="3619022"/>
            <a:ext cx="2969757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53838" y="2428736"/>
            <a:ext cx="2984382" cy="1190286"/>
          </a:xfrm>
        </p:spPr>
        <p:txBody>
          <a:bodyPr anchor="b"/>
          <a:lstStyle>
            <a:lvl1pPr marL="0" indent="0">
              <a:buNone/>
              <a:defRPr sz="1842" b="1"/>
            </a:lvl1pPr>
            <a:lvl2pPr marL="350992" indent="0">
              <a:buNone/>
              <a:defRPr sz="1535" b="1"/>
            </a:lvl2pPr>
            <a:lvl3pPr marL="701985" indent="0">
              <a:buNone/>
              <a:defRPr sz="1382" b="1"/>
            </a:lvl3pPr>
            <a:lvl4pPr marL="1052977" indent="0">
              <a:buNone/>
              <a:defRPr sz="1228" b="1"/>
            </a:lvl4pPr>
            <a:lvl5pPr marL="1403970" indent="0">
              <a:buNone/>
              <a:defRPr sz="1228" b="1"/>
            </a:lvl5pPr>
            <a:lvl6pPr marL="1754962" indent="0">
              <a:buNone/>
              <a:defRPr sz="1228" b="1"/>
            </a:lvl6pPr>
            <a:lvl7pPr marL="2105955" indent="0">
              <a:buNone/>
              <a:defRPr sz="1228" b="1"/>
            </a:lvl7pPr>
            <a:lvl8pPr marL="2456947" indent="0">
              <a:buNone/>
              <a:defRPr sz="1228" b="1"/>
            </a:lvl8pPr>
            <a:lvl9pPr marL="2807940" indent="0">
              <a:buNone/>
              <a:defRPr sz="12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53838" y="3619022"/>
            <a:ext cx="2984382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813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3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198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660506"/>
            <a:ext cx="2264109" cy="2311771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84382" y="1426511"/>
            <a:ext cx="3553837" cy="7040809"/>
          </a:xfrm>
        </p:spPr>
        <p:txBody>
          <a:bodyPr/>
          <a:lstStyle>
            <a:lvl1pPr>
              <a:defRPr sz="2457"/>
            </a:lvl1pPr>
            <a:lvl2pPr>
              <a:defRPr sz="2150"/>
            </a:lvl2pPr>
            <a:lvl3pPr>
              <a:defRPr sz="1842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972276"/>
            <a:ext cx="2264109" cy="5506510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391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34" y="660506"/>
            <a:ext cx="2264109" cy="2311771"/>
          </a:xfrm>
        </p:spPr>
        <p:txBody>
          <a:bodyPr anchor="b"/>
          <a:lstStyle>
            <a:lvl1pPr>
              <a:defRPr sz="245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84382" y="1426511"/>
            <a:ext cx="3553837" cy="7040809"/>
          </a:xfrm>
        </p:spPr>
        <p:txBody>
          <a:bodyPr anchor="t"/>
          <a:lstStyle>
            <a:lvl1pPr marL="0" indent="0">
              <a:buNone/>
              <a:defRPr sz="2457"/>
            </a:lvl1pPr>
            <a:lvl2pPr marL="350992" indent="0">
              <a:buNone/>
              <a:defRPr sz="2150"/>
            </a:lvl2pPr>
            <a:lvl3pPr marL="701985" indent="0">
              <a:buNone/>
              <a:defRPr sz="1842"/>
            </a:lvl3pPr>
            <a:lvl4pPr marL="1052977" indent="0">
              <a:buNone/>
              <a:defRPr sz="1535"/>
            </a:lvl4pPr>
            <a:lvl5pPr marL="1403970" indent="0">
              <a:buNone/>
              <a:defRPr sz="1535"/>
            </a:lvl5pPr>
            <a:lvl6pPr marL="1754962" indent="0">
              <a:buNone/>
              <a:defRPr sz="1535"/>
            </a:lvl6pPr>
            <a:lvl7pPr marL="2105955" indent="0">
              <a:buNone/>
              <a:defRPr sz="1535"/>
            </a:lvl7pPr>
            <a:lvl8pPr marL="2456947" indent="0">
              <a:buNone/>
              <a:defRPr sz="1535"/>
            </a:lvl8pPr>
            <a:lvl9pPr marL="2807940" indent="0">
              <a:buNone/>
              <a:defRPr sz="153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3534" y="2972276"/>
            <a:ext cx="2264109" cy="5506510"/>
          </a:xfrm>
        </p:spPr>
        <p:txBody>
          <a:bodyPr/>
          <a:lstStyle>
            <a:lvl1pPr marL="0" indent="0">
              <a:buNone/>
              <a:defRPr sz="1228"/>
            </a:lvl1pPr>
            <a:lvl2pPr marL="350992" indent="0">
              <a:buNone/>
              <a:defRPr sz="1075"/>
            </a:lvl2pPr>
            <a:lvl3pPr marL="701985" indent="0">
              <a:buNone/>
              <a:defRPr sz="921"/>
            </a:lvl3pPr>
            <a:lvl4pPr marL="1052977" indent="0">
              <a:buNone/>
              <a:defRPr sz="768"/>
            </a:lvl4pPr>
            <a:lvl5pPr marL="1403970" indent="0">
              <a:buNone/>
              <a:defRPr sz="768"/>
            </a:lvl5pPr>
            <a:lvl6pPr marL="1754962" indent="0">
              <a:buNone/>
              <a:defRPr sz="768"/>
            </a:lvl6pPr>
            <a:lvl7pPr marL="2105955" indent="0">
              <a:buNone/>
              <a:defRPr sz="768"/>
            </a:lvl7pPr>
            <a:lvl8pPr marL="2456947" indent="0">
              <a:buNone/>
              <a:defRPr sz="768"/>
            </a:lvl8pPr>
            <a:lvl9pPr marL="2807940" indent="0">
              <a:buNone/>
              <a:defRPr sz="7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812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2620" y="527490"/>
            <a:ext cx="605468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2620" y="2637436"/>
            <a:ext cx="605468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2620" y="9182869"/>
            <a:ext cx="1579483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5FE8FC-6DEB-984A-BAA9-8C6F7AD8111F}" type="datetimeFigureOut">
              <a:rPr kumimoji="1" lang="ja-JP" altLang="en-US" smtClean="0"/>
              <a:t>2024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25350" y="9182869"/>
            <a:ext cx="236922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57822" y="9182869"/>
            <a:ext cx="1579483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1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B2F37E-AC09-754B-B8FB-1CD610B480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24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01985" rtl="0" eaLnBrk="1" latinLnBrk="0" hangingPunct="1">
        <a:lnSpc>
          <a:spcPct val="90000"/>
        </a:lnSpc>
        <a:spcBef>
          <a:spcPct val="0"/>
        </a:spcBef>
        <a:buNone/>
        <a:defRPr kumimoji="1" sz="337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5496" indent="-175496" algn="l" defTabSz="701985" rtl="0" eaLnBrk="1" latinLnBrk="0" hangingPunct="1">
        <a:lnSpc>
          <a:spcPct val="90000"/>
        </a:lnSpc>
        <a:spcBef>
          <a:spcPts val="768"/>
        </a:spcBef>
        <a:buFont typeface="Arial" panose="020B0604020202020204" pitchFamily="34" charset="0"/>
        <a:buChar char="•"/>
        <a:defRPr kumimoji="1" sz="2150" kern="1200">
          <a:solidFill>
            <a:schemeClr val="tx1"/>
          </a:solidFill>
          <a:latin typeface="+mn-lt"/>
          <a:ea typeface="+mn-ea"/>
          <a:cs typeface="+mn-cs"/>
        </a:defRPr>
      </a:lvl1pPr>
      <a:lvl2pPr marL="526489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842" kern="1200">
          <a:solidFill>
            <a:schemeClr val="tx1"/>
          </a:solidFill>
          <a:latin typeface="+mn-lt"/>
          <a:ea typeface="+mn-ea"/>
          <a:cs typeface="+mn-cs"/>
        </a:defRPr>
      </a:lvl2pPr>
      <a:lvl3pPr marL="87748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228474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57946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930458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281451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632443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983436" indent="-175496" algn="l" defTabSz="701985" rtl="0" eaLnBrk="1" latinLnBrk="0" hangingPunct="1">
        <a:lnSpc>
          <a:spcPct val="90000"/>
        </a:lnSpc>
        <a:spcBef>
          <a:spcPts val="384"/>
        </a:spcBef>
        <a:buFont typeface="Arial" panose="020B0604020202020204" pitchFamily="34" charset="0"/>
        <a:buChar char="•"/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1pPr>
      <a:lvl2pPr marL="350992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2pPr>
      <a:lvl3pPr marL="701985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3pPr>
      <a:lvl4pPr marL="1052977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4pPr>
      <a:lvl5pPr marL="1403970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5pPr>
      <a:lvl6pPr marL="1754962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6pPr>
      <a:lvl7pPr marL="2105955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7pPr>
      <a:lvl8pPr marL="2456947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8pPr>
      <a:lvl9pPr marL="2807940" algn="l" defTabSz="701985" rtl="0" eaLnBrk="1" latinLnBrk="0" hangingPunct="1">
        <a:defRPr kumimoji="1" sz="138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9403E97D-98F1-7297-AD8E-42774A716D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3698083" y="666328"/>
            <a:ext cx="3109219" cy="3109219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F70B2A5D-EE88-42C2-A984-037EA73A23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379720" y="666328"/>
            <a:ext cx="3109219" cy="3109219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9EE06B-C8E5-8C14-9F7A-EB754330F30A}"/>
              </a:ext>
            </a:extLst>
          </p:cNvPr>
          <p:cNvSpPr txBox="1"/>
          <p:nvPr/>
        </p:nvSpPr>
        <p:spPr>
          <a:xfrm>
            <a:off x="0" y="303382"/>
            <a:ext cx="1406154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1</a:t>
            </a:r>
            <a:endParaRPr lang="ja-JP" altLang="en-US" sz="1036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52F2A55-AF53-88D6-C8AF-FBF17760206A}"/>
              </a:ext>
            </a:extLst>
          </p:cNvPr>
          <p:cNvSpPr txBox="1"/>
          <p:nvPr/>
        </p:nvSpPr>
        <p:spPr>
          <a:xfrm>
            <a:off x="83908" y="536015"/>
            <a:ext cx="1426994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dirty="0">
                <a:latin typeface="Arial" panose="020B0604020202020204" pitchFamily="34" charset="0"/>
                <a:cs typeface="Arial" panose="020B0604020202020204" pitchFamily="34" charset="0"/>
              </a:rPr>
              <a:t>|log2FC|&gt;0.5, p&lt;0.05</a:t>
            </a:r>
            <a:endParaRPr lang="ja-JP" altLang="en-US" sz="1036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CEED256-6098-A42C-5953-F511C6D57D53}"/>
              </a:ext>
            </a:extLst>
          </p:cNvPr>
          <p:cNvSpPr txBox="1"/>
          <p:nvPr/>
        </p:nvSpPr>
        <p:spPr>
          <a:xfrm rot="16200000">
            <a:off x="132627" y="2760432"/>
            <a:ext cx="441146" cy="1986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91" dirty="0">
                <a:latin typeface="Arial" panose="020B0604020202020204" pitchFamily="34" charset="0"/>
                <a:cs typeface="Arial" panose="020B0604020202020204" pitchFamily="34" charset="0"/>
              </a:rPr>
              <a:t>KEGG</a:t>
            </a:r>
            <a:endParaRPr lang="ja-JP" altLang="en-US" sz="69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9A15B4F-2B9A-192F-23A7-370ED163FAFE}"/>
              </a:ext>
            </a:extLst>
          </p:cNvPr>
          <p:cNvSpPr txBox="1"/>
          <p:nvPr/>
        </p:nvSpPr>
        <p:spPr>
          <a:xfrm rot="16200000">
            <a:off x="58087" y="1457696"/>
            <a:ext cx="590226" cy="1986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91" dirty="0" err="1">
                <a:latin typeface="Arial" panose="020B0604020202020204" pitchFamily="34" charset="0"/>
                <a:cs typeface="Arial" panose="020B0604020202020204" pitchFamily="34" charset="0"/>
              </a:rPr>
              <a:t>Reactome</a:t>
            </a:r>
            <a:endParaRPr lang="ja-JP" altLang="en-US" sz="69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26BA74E1-2D22-48EF-F580-696D3F14786A}"/>
              </a:ext>
            </a:extLst>
          </p:cNvPr>
          <p:cNvCxnSpPr/>
          <p:nvPr/>
        </p:nvCxnSpPr>
        <p:spPr>
          <a:xfrm>
            <a:off x="453969" y="986649"/>
            <a:ext cx="0" cy="114073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27FE2C9-BE0A-92BF-C094-BEDC88868647}"/>
              </a:ext>
            </a:extLst>
          </p:cNvPr>
          <p:cNvCxnSpPr/>
          <p:nvPr/>
        </p:nvCxnSpPr>
        <p:spPr>
          <a:xfrm>
            <a:off x="453969" y="2289385"/>
            <a:ext cx="0" cy="114073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2ACA7E0-0640-DD40-959D-5168FA3FE72C}"/>
              </a:ext>
            </a:extLst>
          </p:cNvPr>
          <p:cNvSpPr txBox="1"/>
          <p:nvPr/>
        </p:nvSpPr>
        <p:spPr>
          <a:xfrm rot="16200000">
            <a:off x="3544915" y="2760432"/>
            <a:ext cx="450764" cy="1986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91" dirty="0">
                <a:latin typeface="Arial" panose="020B0604020202020204" pitchFamily="34" charset="0"/>
                <a:cs typeface="Arial" panose="020B0604020202020204" pitchFamily="34" charset="0"/>
              </a:rPr>
              <a:t>GOMF</a:t>
            </a:r>
            <a:endParaRPr lang="ja-JP" altLang="en-US" sz="69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7571F53-7A4B-5231-DE56-477630830E5E}"/>
              </a:ext>
            </a:extLst>
          </p:cNvPr>
          <p:cNvSpPr txBox="1"/>
          <p:nvPr/>
        </p:nvSpPr>
        <p:spPr>
          <a:xfrm rot="16200000">
            <a:off x="3549722" y="1457696"/>
            <a:ext cx="441146" cy="1986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91" dirty="0">
                <a:latin typeface="Arial" panose="020B0604020202020204" pitchFamily="34" charset="0"/>
                <a:cs typeface="Arial" panose="020B0604020202020204" pitchFamily="34" charset="0"/>
              </a:rPr>
              <a:t>GOBP</a:t>
            </a:r>
            <a:endParaRPr lang="ja-JP" altLang="en-US" sz="69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F9CA0013-0C0C-C90D-459C-38C3F979DEAE}"/>
              </a:ext>
            </a:extLst>
          </p:cNvPr>
          <p:cNvCxnSpPr/>
          <p:nvPr/>
        </p:nvCxnSpPr>
        <p:spPr>
          <a:xfrm>
            <a:off x="3871065" y="986649"/>
            <a:ext cx="0" cy="114073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47E0F07-EB02-AB4D-A136-734EA221C133}"/>
              </a:ext>
            </a:extLst>
          </p:cNvPr>
          <p:cNvCxnSpPr/>
          <p:nvPr/>
        </p:nvCxnSpPr>
        <p:spPr>
          <a:xfrm>
            <a:off x="3871065" y="2289385"/>
            <a:ext cx="0" cy="114073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20522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図 33">
            <a:extLst>
              <a:ext uri="{FF2B5EF4-FFF2-40B4-BE49-F238E27FC236}">
                <a16:creationId xmlns:a16="http://schemas.microsoft.com/office/drawing/2014/main" id="{85E81336-5B49-56B9-884C-E11C54814C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4769" y="4073644"/>
            <a:ext cx="1800000" cy="2298795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29405AB5-5E06-9D23-09C3-168E00508E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31555" y="4035544"/>
            <a:ext cx="1800000" cy="2331325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BAE25184-7E15-A9F2-41B5-B51E683B61A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08341" y="4073644"/>
            <a:ext cx="1800000" cy="229879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A7667E2-0387-414E-C701-7D178A513E70}"/>
              </a:ext>
            </a:extLst>
          </p:cNvPr>
          <p:cNvSpPr txBox="1"/>
          <p:nvPr/>
        </p:nvSpPr>
        <p:spPr>
          <a:xfrm>
            <a:off x="0" y="146398"/>
            <a:ext cx="1406154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2</a:t>
            </a:r>
            <a:endParaRPr lang="ja-JP" altLang="en-US" sz="1036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E14D5DB-A3D0-E2B7-5EED-4C00C28A31E3}"/>
              </a:ext>
            </a:extLst>
          </p:cNvPr>
          <p:cNvSpPr txBox="1"/>
          <p:nvPr/>
        </p:nvSpPr>
        <p:spPr>
          <a:xfrm>
            <a:off x="512142" y="434240"/>
            <a:ext cx="258404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36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527BDE0-63C4-D4C8-F231-795B11042DF6}"/>
              </a:ext>
            </a:extLst>
          </p:cNvPr>
          <p:cNvSpPr txBox="1"/>
          <p:nvPr/>
        </p:nvSpPr>
        <p:spPr>
          <a:xfrm>
            <a:off x="512142" y="4035544"/>
            <a:ext cx="266420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036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8DC6909F-40D2-CBFE-8063-81C3D26556A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19028" y="560108"/>
            <a:ext cx="3981867" cy="2881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9391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EBD000-A29F-7ABE-8B15-91E30666ED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69DD56D-CEDA-6CA9-3F2B-6438579C800D}"/>
              </a:ext>
            </a:extLst>
          </p:cNvPr>
          <p:cNvSpPr txBox="1"/>
          <p:nvPr/>
        </p:nvSpPr>
        <p:spPr>
          <a:xfrm>
            <a:off x="0" y="230803"/>
            <a:ext cx="1406154" cy="25173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36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3</a:t>
            </a:r>
            <a:endParaRPr lang="ja-JP" altLang="en-US" sz="1036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171369D-F0F6-55F3-5DB7-346A327EF3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921"/>
          <a:stretch/>
        </p:blipFill>
        <p:spPr>
          <a:xfrm>
            <a:off x="2516725" y="789009"/>
            <a:ext cx="2025000" cy="1925352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818F574-12F7-0063-D549-7986C08802C9}"/>
              </a:ext>
            </a:extLst>
          </p:cNvPr>
          <p:cNvSpPr txBox="1"/>
          <p:nvPr/>
        </p:nvSpPr>
        <p:spPr>
          <a:xfrm>
            <a:off x="2468031" y="576321"/>
            <a:ext cx="1742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olyarticular JIA (GSE112057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733B0C4-1BCB-3FA1-E23F-97E1D1F22993}"/>
              </a:ext>
            </a:extLst>
          </p:cNvPr>
          <p:cNvSpPr txBox="1"/>
          <p:nvPr/>
        </p:nvSpPr>
        <p:spPr>
          <a:xfrm>
            <a:off x="3699533" y="799540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2.67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AACD53CB-0A7B-D819-DFBD-5D92B076A4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825"/>
          <a:stretch/>
        </p:blipFill>
        <p:spPr>
          <a:xfrm>
            <a:off x="4589401" y="787061"/>
            <a:ext cx="2025000" cy="1927300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B3FBD3A-4DA3-B3E7-A10F-B344D3B57FE2}"/>
              </a:ext>
            </a:extLst>
          </p:cNvPr>
          <p:cNvSpPr txBox="1"/>
          <p:nvPr/>
        </p:nvSpPr>
        <p:spPr>
          <a:xfrm>
            <a:off x="4518781" y="564761"/>
            <a:ext cx="14542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ung cancer (GSE42830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1A8A35D-643B-7F4A-F5D9-4EEA627F358A}"/>
              </a:ext>
            </a:extLst>
          </p:cNvPr>
          <p:cNvSpPr txBox="1"/>
          <p:nvPr/>
        </p:nvSpPr>
        <p:spPr>
          <a:xfrm>
            <a:off x="5777153" y="795071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3.85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CE0983E0-D984-53B4-9775-241B7C9017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654"/>
          <a:stretch/>
        </p:blipFill>
        <p:spPr>
          <a:xfrm>
            <a:off x="451945" y="2900502"/>
            <a:ext cx="2025000" cy="1930746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BE7E092-6C2F-BD21-6933-68133B1950FC}"/>
              </a:ext>
            </a:extLst>
          </p:cNvPr>
          <p:cNvSpPr txBox="1"/>
          <p:nvPr/>
        </p:nvSpPr>
        <p:spPr>
          <a:xfrm>
            <a:off x="410588" y="2678093"/>
            <a:ext cx="11721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troke (GSE16561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DF816AA-1114-6740-3662-6D5C8C2A6481}"/>
              </a:ext>
            </a:extLst>
          </p:cNvPr>
          <p:cNvSpPr txBox="1"/>
          <p:nvPr/>
        </p:nvSpPr>
        <p:spPr>
          <a:xfrm>
            <a:off x="1645160" y="2900502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3.72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32F2F4D9-5201-A6E6-29FB-A42F247148B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921"/>
          <a:stretch/>
        </p:blipFill>
        <p:spPr>
          <a:xfrm>
            <a:off x="2536150" y="2902448"/>
            <a:ext cx="2025000" cy="1925353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7C2ACE7-342B-47CE-D78B-9450B72AFCB2}"/>
              </a:ext>
            </a:extLst>
          </p:cNvPr>
          <p:cNvSpPr txBox="1"/>
          <p:nvPr/>
        </p:nvSpPr>
        <p:spPr>
          <a:xfrm>
            <a:off x="2468031" y="2686054"/>
            <a:ext cx="15055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ystemic JIA (GSE80060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C829A05-3140-F0F6-D981-4D60F04E9FE1}"/>
              </a:ext>
            </a:extLst>
          </p:cNvPr>
          <p:cNvSpPr txBox="1"/>
          <p:nvPr/>
        </p:nvSpPr>
        <p:spPr>
          <a:xfrm>
            <a:off x="3723902" y="2925442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5.10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図 26">
            <a:extLst>
              <a:ext uri="{FF2B5EF4-FFF2-40B4-BE49-F238E27FC236}">
                <a16:creationId xmlns:a16="http://schemas.microsoft.com/office/drawing/2014/main" id="{7ED6315C-B87D-8097-4734-E562F36A37B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825"/>
          <a:stretch/>
        </p:blipFill>
        <p:spPr>
          <a:xfrm>
            <a:off x="4608826" y="2900502"/>
            <a:ext cx="2025000" cy="192730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CF5940B-7400-1FEF-9267-33118B310BBD}"/>
              </a:ext>
            </a:extLst>
          </p:cNvPr>
          <p:cNvSpPr txBox="1"/>
          <p:nvPr/>
        </p:nvSpPr>
        <p:spPr>
          <a:xfrm>
            <a:off x="4540707" y="2684321"/>
            <a:ext cx="18453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heumatoid arthritis (GSE90081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8957194-2A09-71AB-EB3E-B1DC4ABD73D3}"/>
              </a:ext>
            </a:extLst>
          </p:cNvPr>
          <p:cNvSpPr txBox="1"/>
          <p:nvPr/>
        </p:nvSpPr>
        <p:spPr>
          <a:xfrm>
            <a:off x="5790512" y="2925444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3.16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図 32">
            <a:extLst>
              <a:ext uri="{FF2B5EF4-FFF2-40B4-BE49-F238E27FC236}">
                <a16:creationId xmlns:a16="http://schemas.microsoft.com/office/drawing/2014/main" id="{70D2812D-EB35-B057-C9EC-E5BD579DF7FD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5174"/>
          <a:stretch/>
        </p:blipFill>
        <p:spPr>
          <a:xfrm>
            <a:off x="437580" y="789009"/>
            <a:ext cx="2030400" cy="1925353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0712206-8515-2CE5-6D51-75D4AC426395}"/>
              </a:ext>
            </a:extLst>
          </p:cNvPr>
          <p:cNvSpPr txBox="1"/>
          <p:nvPr/>
        </p:nvSpPr>
        <p:spPr>
          <a:xfrm>
            <a:off x="371838" y="581694"/>
            <a:ext cx="21852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ajor depressive disorder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GSE76826)</a:t>
            </a:r>
            <a:endParaRPr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76B23DF-2BC8-D65D-D8A7-B846FCDC01FF}"/>
              </a:ext>
            </a:extLst>
          </p:cNvPr>
          <p:cNvSpPr txBox="1"/>
          <p:nvPr/>
        </p:nvSpPr>
        <p:spPr>
          <a:xfrm>
            <a:off x="1645713" y="824016"/>
            <a:ext cx="8579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NES = 3.49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Nominal p &lt; 0.0001</a:t>
            </a:r>
          </a:p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     FDR q &lt; 0.0001</a:t>
            </a:r>
            <a:endParaRPr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416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88</TotalTime>
  <Words>135</Words>
  <Application>Microsoft Macintosh PowerPoint</Application>
  <PresentationFormat>ユーザー設定</PresentationFormat>
  <Paragraphs>35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亮太 貫和</dc:creator>
  <cp:lastModifiedBy>亮太 貫和</cp:lastModifiedBy>
  <cp:revision>115</cp:revision>
  <dcterms:created xsi:type="dcterms:W3CDTF">2024-07-05T01:50:01Z</dcterms:created>
  <dcterms:modified xsi:type="dcterms:W3CDTF">2024-12-19T00:48:15Z</dcterms:modified>
</cp:coreProperties>
</file>